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13" autoAdjust="0"/>
    <p:restoredTop sz="96702" autoAdjust="0"/>
  </p:normalViewPr>
  <p:slideViewPr>
    <p:cSldViewPr snapToGrid="0">
      <p:cViewPr>
        <p:scale>
          <a:sx n="80" d="100"/>
          <a:sy n="80" d="100"/>
        </p:scale>
        <p:origin x="-1360" y="-3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042A8A-5856-4E00-BCE1-86D6D2AEA46E}" type="datetimeFigureOut">
              <a:rPr lang="en-US" smtClean="0"/>
              <a:t>9/12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667484-D6EC-4FFF-864D-E18CD0DFC9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6227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092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063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055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952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143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679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173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202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173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974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725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299B36-A8CF-440E-9535-094268358ACB}" type="datetimeFigureOut">
              <a:rPr lang="en-US" smtClean="0"/>
              <a:t>9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40900-F396-4088-9601-501F5E4F5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496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="" xmlns:a16="http://schemas.microsoft.com/office/drawing/2014/main" id="{4B2A085C-CAE9-46E8-9FF9-659AA29551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127" y="1255645"/>
            <a:ext cx="1646190" cy="71542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ACE1AD29-AC8F-4B38-9FC6-EE94D5DCF1D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2397" y="261366"/>
            <a:ext cx="1540910" cy="80873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="" xmlns:a16="http://schemas.microsoft.com/office/drawing/2014/main" id="{0EE2F88F-F464-4ED6-9C28-6CE262353E4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843" y="261366"/>
            <a:ext cx="1540910" cy="808739"/>
          </a:xfrm>
          <a:prstGeom prst="rect">
            <a:avLst/>
          </a:prstGeom>
        </p:spPr>
      </p:pic>
      <p:sp>
        <p:nvSpPr>
          <p:cNvPr id="11" name="Rectangle 415">
            <a:extLst>
              <a:ext uri="{FF2B5EF4-FFF2-40B4-BE49-F238E27FC236}">
                <a16:creationId xmlns="" xmlns:a16="http://schemas.microsoft.com/office/drawing/2014/main" id="{47F5B92C-DDB6-4BE6-9F93-D2615557FE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217" y="1581902"/>
            <a:ext cx="4969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" name="Rectangle 419">
            <a:extLst>
              <a:ext uri="{FF2B5EF4-FFF2-40B4-BE49-F238E27FC236}">
                <a16:creationId xmlns="" xmlns:a16="http://schemas.microsoft.com/office/drawing/2014/main" id="{2F94F257-3E67-4B3F-A9B5-0A9FF45D14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8523" y="1264815"/>
            <a:ext cx="9938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>
                <a:solidFill>
                  <a:srgbClr val="000000"/>
                </a:solidFill>
                <a:cs typeface="Arial" panose="020B0604020202020204" pitchFamily="34" charset="0"/>
              </a:rPr>
              <a:t>2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555191C6-1B57-4542-BC26-324491A0BA4E}"/>
              </a:ext>
            </a:extLst>
          </p:cNvPr>
          <p:cNvSpPr txBox="1"/>
          <p:nvPr/>
        </p:nvSpPr>
        <p:spPr>
          <a:xfrm rot="16200000">
            <a:off x="-272335" y="1534784"/>
            <a:ext cx="11443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eak Density (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/pF)</a:t>
            </a:r>
          </a:p>
        </p:txBody>
      </p:sp>
      <p:sp>
        <p:nvSpPr>
          <p:cNvPr id="14" name="Rectangle 419">
            <a:extLst>
              <a:ext uri="{FF2B5EF4-FFF2-40B4-BE49-F238E27FC236}">
                <a16:creationId xmlns="" xmlns:a16="http://schemas.microsoft.com/office/drawing/2014/main" id="{C74DA214-DDEA-4657-830B-E10D97AACD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8066" y="1893507"/>
            <a:ext cx="12984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>
                <a:solidFill>
                  <a:srgbClr val="000000"/>
                </a:solidFill>
                <a:cs typeface="Arial" panose="020B0604020202020204" pitchFamily="34" charset="0"/>
              </a:rPr>
              <a:t>-2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" name="Rectangle 1176">
            <a:extLst>
              <a:ext uri="{FF2B5EF4-FFF2-40B4-BE49-F238E27FC236}">
                <a16:creationId xmlns="" xmlns:a16="http://schemas.microsoft.com/office/drawing/2014/main" id="{405CADF4-9797-4557-8B69-7A86660AC3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2681" y="1768070"/>
            <a:ext cx="76944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est Potential (mV)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Rectangle 407">
            <a:extLst>
              <a:ext uri="{FF2B5EF4-FFF2-40B4-BE49-F238E27FC236}">
                <a16:creationId xmlns="" xmlns:a16="http://schemas.microsoft.com/office/drawing/2014/main" id="{E2CD18D4-FFF2-4859-9C12-AD135AFCB6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5742" y="1660791"/>
            <a:ext cx="12984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-8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" name="Rectangle 408">
            <a:extLst>
              <a:ext uri="{FF2B5EF4-FFF2-40B4-BE49-F238E27FC236}">
                <a16:creationId xmlns="" xmlns:a16="http://schemas.microsoft.com/office/drawing/2014/main" id="{D7F445FD-412D-4450-A199-32459E8C47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8186" y="1660791"/>
            <a:ext cx="12984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-6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" name="Rectangle 409">
            <a:extLst>
              <a:ext uri="{FF2B5EF4-FFF2-40B4-BE49-F238E27FC236}">
                <a16:creationId xmlns="" xmlns:a16="http://schemas.microsoft.com/office/drawing/2014/main" id="{19837A61-90A8-492D-AA66-B852BC2714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64843" y="1660791"/>
            <a:ext cx="12984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-4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" name="Rectangle 410">
            <a:extLst>
              <a:ext uri="{FF2B5EF4-FFF2-40B4-BE49-F238E27FC236}">
                <a16:creationId xmlns="" xmlns:a16="http://schemas.microsoft.com/office/drawing/2014/main" id="{CE9FE4F6-862B-4DD7-9D91-BC6C027DAD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29230" y="1660791"/>
            <a:ext cx="12984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-20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" name="Rectangle 1176">
            <a:extLst>
              <a:ext uri="{FF2B5EF4-FFF2-40B4-BE49-F238E27FC236}">
                <a16:creationId xmlns="" xmlns:a16="http://schemas.microsoft.com/office/drawing/2014/main" id="{8C5EFE41-A232-4B1A-BACF-DEE4927581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853" y="264067"/>
            <a:ext cx="11110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0 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endParaRPr kumimoji="0" lang="en-US" altLang="en-US" sz="90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Rectangle 1176">
            <a:extLst>
              <a:ext uri="{FF2B5EF4-FFF2-40B4-BE49-F238E27FC236}">
                <a16:creationId xmlns="" xmlns:a16="http://schemas.microsoft.com/office/drawing/2014/main" id="{CE9B068C-2BC0-4E94-B936-169DA17099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9638" y="264067"/>
            <a:ext cx="11110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 mM C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+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/ 20mM Na</a:t>
            </a:r>
            <a:r>
              <a:rPr kumimoji="0" lang="en-US" altLang="en-US" sz="9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+</a:t>
            </a:r>
            <a:endParaRPr kumimoji="0" lang="en-US" altLang="en-US" sz="900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" name="Rectangle 282">
            <a:extLst>
              <a:ext uri="{FF2B5EF4-FFF2-40B4-BE49-F238E27FC236}">
                <a16:creationId xmlns="" xmlns:a16="http://schemas.microsoft.com/office/drawing/2014/main" id="{807730F5-0C85-4317-9435-FB4DCD1E09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81" y="1010582"/>
            <a:ext cx="2917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100</a:t>
            </a:r>
            <a:r>
              <a:rPr kumimoji="0" lang="en-US" altLang="en-US" sz="6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mV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" name="Rectangle 282">
            <a:extLst>
              <a:ext uri="{FF2B5EF4-FFF2-40B4-BE49-F238E27FC236}">
                <a16:creationId xmlns="" xmlns:a16="http://schemas.microsoft.com/office/drawing/2014/main" id="{570AB330-B38C-439C-9D47-642A9BFCE1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8703" y="720727"/>
            <a:ext cx="2484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25 mV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="" xmlns:a16="http://schemas.microsoft.com/office/drawing/2014/main" id="{5FE85D37-0B6F-4636-BC49-ED3D29094CC7}"/>
              </a:ext>
            </a:extLst>
          </p:cNvPr>
          <p:cNvSpPr/>
          <p:nvPr/>
        </p:nvSpPr>
        <p:spPr>
          <a:xfrm>
            <a:off x="73295" y="2196681"/>
            <a:ext cx="245160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Figure 1. Wang et al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112">
            <a:extLst>
              <a:ext uri="{FF2B5EF4-FFF2-40B4-BE49-F238E27FC236}">
                <a16:creationId xmlns="" xmlns:a16="http://schemas.microsoft.com/office/drawing/2014/main" id="{414A87D4-44DB-404D-BEAE-BDCFD818AB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56" y="191392"/>
            <a:ext cx="109005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12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2836863" indent="-1090613">
              <a:spcBef>
                <a:spcPct val="20000"/>
              </a:spcBef>
              <a:buChar char="–"/>
              <a:defRPr sz="10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4362450" indent="-871538">
              <a:spcBef>
                <a:spcPct val="20000"/>
              </a:spcBef>
              <a:buChar char="•"/>
              <a:defRPr sz="91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6107113" indent="-871538">
              <a:spcBef>
                <a:spcPct val="20000"/>
              </a:spcBef>
              <a:buChar char="–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7853363" indent="-871538">
              <a:spcBef>
                <a:spcPct val="20000"/>
              </a:spcBef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83105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87677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92249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96821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dirty="0">
                <a:cs typeface="Arial" panose="020B0604020202020204" pitchFamily="34" charset="0"/>
              </a:rPr>
              <a:t>A.</a:t>
            </a:r>
          </a:p>
        </p:txBody>
      </p:sp>
      <p:sp>
        <p:nvSpPr>
          <p:cNvPr id="26" name="Rectangle 2112">
            <a:extLst>
              <a:ext uri="{FF2B5EF4-FFF2-40B4-BE49-F238E27FC236}">
                <a16:creationId xmlns="" xmlns:a16="http://schemas.microsoft.com/office/drawing/2014/main" id="{C8B6FEF3-0889-4CB9-91A4-0E6BC6389E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56" y="1109051"/>
            <a:ext cx="109004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12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2836863" indent="-1090613">
              <a:spcBef>
                <a:spcPct val="20000"/>
              </a:spcBef>
              <a:buChar char="–"/>
              <a:defRPr sz="10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4362450" indent="-871538">
              <a:spcBef>
                <a:spcPct val="20000"/>
              </a:spcBef>
              <a:buChar char="•"/>
              <a:defRPr sz="91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6107113" indent="-871538">
              <a:spcBef>
                <a:spcPct val="20000"/>
              </a:spcBef>
              <a:buChar char="–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7853363" indent="-871538">
              <a:spcBef>
                <a:spcPct val="20000"/>
              </a:spcBef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83105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87677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92249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9682163" indent="-871538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7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dirty="0"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1426157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5</TotalTime>
  <Words>59</Words>
  <Application>Microsoft Macintosh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rbonne_lab</dc:creator>
  <cp:lastModifiedBy>William Balke</cp:lastModifiedBy>
  <cp:revision>64</cp:revision>
  <dcterms:created xsi:type="dcterms:W3CDTF">2018-08-30T17:55:50Z</dcterms:created>
  <dcterms:modified xsi:type="dcterms:W3CDTF">2018-09-12T18:37:16Z</dcterms:modified>
</cp:coreProperties>
</file>